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9900"/>
    <a:srgbClr val="FF66CC"/>
    <a:srgbClr val="00CCFF"/>
    <a:srgbClr val="33CCCC"/>
    <a:srgbClr val="FF99FF"/>
    <a:srgbClr val="669E40"/>
    <a:srgbClr val="11C1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4" autoAdjust="0"/>
    <p:restoredTop sz="94660"/>
  </p:normalViewPr>
  <p:slideViewPr>
    <p:cSldViewPr snapToGrid="0">
      <p:cViewPr>
        <p:scale>
          <a:sx n="125" d="100"/>
          <a:sy n="125" d="100"/>
        </p:scale>
        <p:origin x="858" y="-25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674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096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624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116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798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021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126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29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217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690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313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020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73396E75-BABE-6E75-2526-BB170DAD8FAC}"/>
              </a:ext>
            </a:extLst>
          </p:cNvPr>
          <p:cNvGrpSpPr/>
          <p:nvPr/>
        </p:nvGrpSpPr>
        <p:grpSpPr>
          <a:xfrm>
            <a:off x="899723" y="185669"/>
            <a:ext cx="5274310" cy="2814955"/>
            <a:chOff x="899723" y="185669"/>
            <a:chExt cx="5274310" cy="2814955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60C128D4-3579-4C75-9624-1ECFE7BFCEB4}"/>
                </a:ext>
              </a:extLst>
            </p:cNvPr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899723" y="185669"/>
              <a:ext cx="5274310" cy="2814955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997656E2-1CED-4BB9-AD32-41943C5262B3}"/>
                </a:ext>
              </a:extLst>
            </p:cNvPr>
            <p:cNvSpPr txBox="1"/>
            <p:nvPr/>
          </p:nvSpPr>
          <p:spPr>
            <a:xfrm>
              <a:off x="1250066" y="185669"/>
              <a:ext cx="2811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D3850E9C-4432-BBDA-2D1E-563B381B7554}"/>
              </a:ext>
            </a:extLst>
          </p:cNvPr>
          <p:cNvGrpSpPr/>
          <p:nvPr/>
        </p:nvGrpSpPr>
        <p:grpSpPr>
          <a:xfrm>
            <a:off x="899723" y="2941795"/>
            <a:ext cx="5429468" cy="3473259"/>
            <a:chOff x="899723" y="2941795"/>
            <a:chExt cx="5429468" cy="3473259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3E3BC773-E594-41F2-8E7A-5B6BADFAE152}"/>
                </a:ext>
              </a:extLst>
            </p:cNvPr>
            <p:cNvSpPr txBox="1"/>
            <p:nvPr/>
          </p:nvSpPr>
          <p:spPr>
            <a:xfrm>
              <a:off x="1250066" y="2941795"/>
              <a:ext cx="2811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052D5A58-3205-51CA-E74B-32616F0339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99723" y="3273228"/>
              <a:ext cx="5429468" cy="3141826"/>
            </a:xfrm>
            <a:prstGeom prst="rect">
              <a:avLst/>
            </a:prstGeom>
          </p:spPr>
        </p:pic>
      </p:grpSp>
      <p:sp>
        <p:nvSpPr>
          <p:cNvPr id="5" name="TextBox 6">
            <a:extLst>
              <a:ext uri="{FF2B5EF4-FFF2-40B4-BE49-F238E27FC236}">
                <a16:creationId xmlns:a16="http://schemas.microsoft.com/office/drawing/2014/main" id="{CC49C276-BFFE-0D01-710C-15D5597B4B2E}"/>
              </a:ext>
            </a:extLst>
          </p:cNvPr>
          <p:cNvSpPr txBox="1"/>
          <p:nvPr/>
        </p:nvSpPr>
        <p:spPr>
          <a:xfrm>
            <a:off x="577411" y="6687658"/>
            <a:ext cx="570317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igure</a:t>
            </a:r>
            <a:r>
              <a:rPr lang="zh-CN" alt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ule detection of weighted gene co-expression network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Network topology analysis for various soft-thresholding powers. The left figure showed the scale-free fit index (y-axis) as a function of the soft-thresholding power (x-axis). The right figure showed 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 mean connectivity (y-axis) as a function of the soft-thresholding power (x-axis). The cut-off for soft-threshold reached 0.85, 16 power-value were selected. 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ne clustering tre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TO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similarity. Each leaf in the tree indicates one gene. Branches of the tree comprise 26 modules, marked by different colors in the heatmap. TOM,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opological overlap measure.</a:t>
            </a:r>
          </a:p>
        </p:txBody>
      </p:sp>
    </p:spTree>
    <p:extLst>
      <p:ext uri="{BB962C8B-B14F-4D97-AF65-F5344CB8AC3E}">
        <p14:creationId xmlns:p14="http://schemas.microsoft.com/office/powerpoint/2010/main" val="804860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1</TotalTime>
  <Words>11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exas A and M AgriLif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Meiping</dc:creator>
  <cp:lastModifiedBy>MDPI</cp:lastModifiedBy>
  <cp:revision>93</cp:revision>
  <dcterms:created xsi:type="dcterms:W3CDTF">2022-03-07T00:48:16Z</dcterms:created>
  <dcterms:modified xsi:type="dcterms:W3CDTF">2024-07-10T09:23:36Z</dcterms:modified>
</cp:coreProperties>
</file>